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90" d="100"/>
          <a:sy n="90" d="100"/>
        </p:scale>
        <p:origin x="35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emarie Bardelmeijer" userId="519a7264eed128a7" providerId="LiveId" clId="{9B387A01-8347-4544-BF27-40C01B155725}"/>
    <pc:docChg chg="undo custSel modSld">
      <pc:chgData name="Annemarie Bardelmeijer" userId="519a7264eed128a7" providerId="LiveId" clId="{9B387A01-8347-4544-BF27-40C01B155725}" dt="2024-10-23T10:10:23.224" v="15" actId="403"/>
      <pc:docMkLst>
        <pc:docMk/>
      </pc:docMkLst>
      <pc:sldChg chg="addSp delSp modSp mod">
        <pc:chgData name="Annemarie Bardelmeijer" userId="519a7264eed128a7" providerId="LiveId" clId="{9B387A01-8347-4544-BF27-40C01B155725}" dt="2024-10-23T10:10:23.224" v="15" actId="403"/>
        <pc:sldMkLst>
          <pc:docMk/>
          <pc:sldMk cId="2818794904" sldId="256"/>
        </pc:sldMkLst>
      </pc:sldChg>
    </pc:docChg>
  </pc:docChgLst>
  <pc:docChgLst>
    <pc:chgData name="Jong-Bardelmeijer, AL de" userId="eac6435b-c1c8-4a83-8ad1-d541506c1f55" providerId="ADAL" clId="{CE7B640E-4AE3-4E39-882F-5E642B7B5F7C}"/>
    <pc:docChg chg="modSld">
      <pc:chgData name="Jong-Bardelmeijer, AL de" userId="eac6435b-c1c8-4a83-8ad1-d541506c1f55" providerId="ADAL" clId="{CE7B640E-4AE3-4E39-882F-5E642B7B5F7C}" dt="2025-07-23T12:40:39.798" v="1" actId="20577"/>
      <pc:docMkLst>
        <pc:docMk/>
      </pc:docMkLst>
      <pc:sldChg chg="modSp mod">
        <pc:chgData name="Jong-Bardelmeijer, AL de" userId="eac6435b-c1c8-4a83-8ad1-d541506c1f55" providerId="ADAL" clId="{CE7B640E-4AE3-4E39-882F-5E642B7B5F7C}" dt="2025-07-23T12:40:39.798" v="1" actId="20577"/>
        <pc:sldMkLst>
          <pc:docMk/>
          <pc:sldMk cId="2818794904" sldId="256"/>
        </pc:sldMkLst>
        <pc:spChg chg="mod">
          <ac:chgData name="Jong-Bardelmeijer, AL de" userId="eac6435b-c1c8-4a83-8ad1-d541506c1f55" providerId="ADAL" clId="{CE7B640E-4AE3-4E39-882F-5E642B7B5F7C}" dt="2025-07-23T12:40:39.798" v="1" actId="20577"/>
          <ac:spMkLst>
            <pc:docMk/>
            <pc:sldMk cId="2818794904" sldId="256"/>
            <ac:spMk id="5" creationId="{DDA3BF2A-10AE-177B-5974-081D54B7B5B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082B4E-CC09-DB46-A11C-9362915CF1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36013859-2952-308A-11F6-79D46EA9F5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DF80B2C-2BBA-D52B-1729-848FD2AEF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612C8270-4198-B2E0-2210-D8CB12D00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EE55B43-8FAA-A11F-E828-4FD4543F3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5335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D1DBA92-DF8E-7D2E-E465-36AC81A77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3FD1EB5B-6404-32B6-5477-730D9D9020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376F1C2-3C6D-C6D0-B91A-08F6E5519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E1F3663-10AC-A842-2FA9-60955692D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51B2B62D-E8A1-9BA5-2193-AD515A766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3285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AA927378-E060-C26A-5B40-CFB120A44E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E879E834-1ACE-A8E0-2211-27BEC5306C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EB64310-19AA-D13D-B33C-07D889280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24CAA73-52A5-F5D4-79C5-2756871E3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FA51D0C-728D-99C2-4227-2DE387EC4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97997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999C8D-E3DD-B608-7D6E-2F976E6A50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78688AF7-9F9F-3787-39CC-B5FCA26635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2ED5177-A6B2-F7E9-C659-5A4A8CE92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A2B3BF2-EE11-279C-8891-BB62A40B6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CB2F195-F580-B9F2-7995-CD069F469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34866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F9DF902-B3FE-2BF9-DF67-5D77C8BDA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BB24523A-91EE-A614-74A5-1B065C3EF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B6B49501-11A7-CCD9-2BC6-3E1DC4B31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943B227-1D83-86DD-84E6-FE067DA68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42E4F0B8-6AD9-F44D-0809-A47CA4F37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85495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B5DB046-5059-95E8-9448-E07F75A31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8C1E987-D341-A42F-9AC4-1914A7EAC0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B65A2C38-B555-BC04-78DE-051FF2FDC6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D371A011-D1D6-5C82-E8AD-C6A79CEAA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E420CA85-9F72-7BCE-0D01-8B7702584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47E7A40F-E138-DFDA-2095-D53723415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C4B9BD9-9F1A-A6ED-7018-79CFEBA6D3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0E782E56-3676-66AD-133E-3F47C064CB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F3C615F7-C6AC-0BDE-A1D7-F8EF17A468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8EDDFD8F-8825-24C3-557C-E5360049F6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C779EA7C-04BF-9732-A8FC-6EF8FCAF71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65AD115E-C666-C54A-5A32-8A94658D2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8528B1B8-A14C-5E63-C5A0-1EDB8E59B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77006971-70A3-1D2C-DEA5-41D36A052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31424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5855D8-9853-2F4E-179A-18C50235EA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F153E00B-4A28-9CE1-378D-B460AA6BD9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F181F1C6-648B-0472-1D6D-746098EC3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11D73652-B229-7864-DCF3-11129982E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0296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7F700424-BB93-B1BA-0FB0-24B146C38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AE9FDE50-86D0-EE63-3CFB-AE71CA3E0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709AB774-6672-BE69-7EC3-6206CB3D6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94441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C8E523-A300-5767-5835-9942E31282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CD5A643-7ABD-72C1-218F-5EBB944B60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6A416A82-72CB-AABE-6A14-4E3867880D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D1A1452C-E432-126E-4898-F714874FF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CFCDC96-ADD7-6EF1-8599-0EBEE6842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4D652BBB-3440-BCDB-5690-39B58E66B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20285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871081-E48C-588F-8FDE-028E4648D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E2DF1BD2-87E9-9F44-E136-9FEC178B1D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09F46B0C-E6F3-AE99-C076-CF3909F843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8977659B-A825-A3CA-668B-4DCFC2840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E7E01FD1-522F-B78B-16CB-EB935BC13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E024A95B-D52D-B591-8B68-F0483E18E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26519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B6D2707E-0D5E-36CD-299B-2A25E9984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F163A3A-33BD-AD9E-1075-4C4756CA94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C7E9F3D-9768-25A6-0039-04F858E04B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79870-A76F-4DDF-A2E2-245439D5C270}" type="datetimeFigureOut">
              <a:rPr lang="nl-NL" smtClean="0"/>
              <a:t>23-7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5467CED-4247-589F-A328-08895D7B54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96B313B-B642-88BD-6CCC-6A9CA7B601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1C768-2C9B-4AB1-ABEB-490854B7B56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92839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>
            <a:extLst>
              <a:ext uri="{FF2B5EF4-FFF2-40B4-BE49-F238E27FC236}">
                <a16:creationId xmlns:a16="http://schemas.microsoft.com/office/drawing/2014/main" id="{DDA3BF2A-10AE-177B-5974-081D54B7B5BF}"/>
              </a:ext>
            </a:extLst>
          </p:cNvPr>
          <p:cNvSpPr txBox="1"/>
          <p:nvPr/>
        </p:nvSpPr>
        <p:spPr>
          <a:xfrm>
            <a:off x="1909482" y="708212"/>
            <a:ext cx="8633012" cy="782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Bef>
                <a:spcPts val="1200"/>
              </a:spcBef>
            </a:pPr>
            <a:r>
              <a:rPr lang="en-GB" sz="1400" b="1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Material</a:t>
            </a:r>
            <a:endParaRPr lang="nl-NL" sz="1400" b="1" kern="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en-GB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nl-NL" sz="14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GB" sz="1400" b="1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able S2.</a:t>
            </a:r>
            <a:r>
              <a:rPr lang="en-GB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istribution of health problems reported by respondents in the open text box. </a:t>
            </a:r>
            <a:endParaRPr lang="nl-NL" sz="14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el 5">
            <a:extLst>
              <a:ext uri="{FF2B5EF4-FFF2-40B4-BE49-F238E27FC236}">
                <a16:creationId xmlns:a16="http://schemas.microsoft.com/office/drawing/2014/main" id="{46E05FC7-83E3-0BC8-F894-371247C2CD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5372406"/>
              </p:ext>
            </p:extLst>
          </p:nvPr>
        </p:nvGraphicFramePr>
        <p:xfrm>
          <a:off x="1990165" y="1709876"/>
          <a:ext cx="8552328" cy="446442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2368736">
                  <a:extLst>
                    <a:ext uri="{9D8B030D-6E8A-4147-A177-3AD203B41FA5}">
                      <a16:colId xmlns:a16="http://schemas.microsoft.com/office/drawing/2014/main" val="822078178"/>
                    </a:ext>
                  </a:extLst>
                </a:gridCol>
                <a:gridCol w="1447046">
                  <a:extLst>
                    <a:ext uri="{9D8B030D-6E8A-4147-A177-3AD203B41FA5}">
                      <a16:colId xmlns:a16="http://schemas.microsoft.com/office/drawing/2014/main" val="1333977050"/>
                    </a:ext>
                  </a:extLst>
                </a:gridCol>
                <a:gridCol w="3289500">
                  <a:extLst>
                    <a:ext uri="{9D8B030D-6E8A-4147-A177-3AD203B41FA5}">
                      <a16:colId xmlns:a16="http://schemas.microsoft.com/office/drawing/2014/main" val="1905727359"/>
                    </a:ext>
                  </a:extLst>
                </a:gridCol>
                <a:gridCol w="1447046">
                  <a:extLst>
                    <a:ext uri="{9D8B030D-6E8A-4147-A177-3AD203B41FA5}">
                      <a16:colId xmlns:a16="http://schemas.microsoft.com/office/drawing/2014/main" val="2229483966"/>
                    </a:ext>
                  </a:extLst>
                </a:gridCol>
              </a:tblGrid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b="1" kern="100" dirty="0">
                          <a:effectLst/>
                        </a:rPr>
                        <a:t>Health problems</a:t>
                      </a:r>
                      <a:endParaRPr lang="nl-NL" sz="14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b="1" kern="100" dirty="0">
                          <a:effectLst/>
                        </a:rPr>
                        <a:t>Number of times</a:t>
                      </a:r>
                      <a:endParaRPr lang="nl-NL" sz="14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b="1" kern="100" dirty="0">
                          <a:effectLst/>
                        </a:rPr>
                        <a:t>Health problems</a:t>
                      </a:r>
                      <a:endParaRPr lang="nl-NL" sz="14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b="1" kern="100" dirty="0">
                          <a:effectLst/>
                        </a:rPr>
                        <a:t>Number of times</a:t>
                      </a:r>
                      <a:endParaRPr lang="nl-NL" sz="14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6083357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Cesarean scar pain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8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 dirty="0">
                          <a:effectLst/>
                        </a:rPr>
                        <a:t>Headache 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3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92446143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Tailbone pain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3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Carpal tunnel syndrome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2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0739504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</a:rPr>
                        <a:t>Episiotomy scar pain 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</a:rPr>
                        <a:t>9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Constipation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2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83961388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Overworked/burnout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9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Varicose vein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2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36259641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Prolapse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9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Leg pain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2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21915356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</a:rPr>
                        <a:t>Thyroid problems 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7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Short of breath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72537468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Menstrual cycle problems 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6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Insecuritie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96869734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Concentration problems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</a:rPr>
                        <a:t>6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Night sweat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3487378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Mood swings/anger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7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Palpitation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93950456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Diastasis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5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Ischai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6457208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Dizziness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5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Umbilical hernia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67304484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Shoulder pain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5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PTSD form crying baby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2158362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Mastitis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4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PTSD related to childs health problem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62633589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Joint pain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4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Hormonal complaint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35769461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Abdominal pain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4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Hip pain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48207859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Stress/anxiety not childbirth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4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Fecal incontinence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17328387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Tired muscles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3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Sleep problem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53820089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Anal fissure 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3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>
                          <a:effectLst/>
                        </a:rPr>
                        <a:t>Forgetfulness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>
                          <a:effectLst/>
                        </a:rPr>
                        <a:t>1</a:t>
                      </a:r>
                      <a:endParaRPr lang="nl-NL" sz="14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13384107"/>
                  </a:ext>
                </a:extLst>
              </a:tr>
              <a:tr h="223221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nl-NL" sz="1000" kern="100" dirty="0">
                          <a:effectLst/>
                        </a:rPr>
                        <a:t>Overstimulation 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</a:rPr>
                        <a:t>3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</a:rPr>
                        <a:t> 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</a:pPr>
                      <a:r>
                        <a:rPr lang="en-GB" sz="1000" kern="100" dirty="0">
                          <a:effectLst/>
                        </a:rPr>
                        <a:t> </a:t>
                      </a:r>
                      <a:endParaRPr lang="nl-NL" sz="14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09121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1879490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48</Words>
  <Application>Microsoft Office PowerPoint</Application>
  <PresentationFormat>Breedbeeld</PresentationFormat>
  <Paragraphs>83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emarie Bardelmeijer</dc:creator>
  <cp:lastModifiedBy>Jong-Bardelmeijer, AL de</cp:lastModifiedBy>
  <cp:revision>1</cp:revision>
  <dcterms:created xsi:type="dcterms:W3CDTF">2024-10-23T10:03:12Z</dcterms:created>
  <dcterms:modified xsi:type="dcterms:W3CDTF">2025-07-23T12:40:42Z</dcterms:modified>
</cp:coreProperties>
</file>